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58" r:id="rId3"/>
    <p:sldId id="259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84"/>
    <p:restoredTop sz="92589"/>
  </p:normalViewPr>
  <p:slideViewPr>
    <p:cSldViewPr snapToGrid="0" snapToObjects="1">
      <p:cViewPr>
        <p:scale>
          <a:sx n="94" d="100"/>
          <a:sy n="94" d="100"/>
        </p:scale>
        <p:origin x="7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85BD6E-8D5B-F949-A79B-2C8B254AA33F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AABA09-3495-6C42-B662-1AC3EBD946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766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mitochondrial oxygen consumption spectra using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oboro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xygraph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k. Briefly, 1-2 mg of muscle are introduced in the chambers afte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meabilizatio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apon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ebbistatin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used to block contraction. After that Malate, Glutamate, Succinate, the electron donors for NAD+, Complex I and Complex II are added.  8 ADP titrations are performed at different concentrations (from 31.25µM to 2mM). Finally 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 (10 µM) is added to check the integrity of the membrane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5E7799-5A10-584D-B949-DAE435D387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0801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scatterplots showing the association between mitochondrial respiration and body compositio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relationships between State 3 (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P) or Submaximal State 3 (0.25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P) with BMI (upper panels) and fat mass (lower panels) are presented after adjustment for sex and age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6A13C6-2DCD-DF4A-A164-7AF6BA6D285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7416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scatterplots showing the association between mitochondrial respiration and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PCr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VO2max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The relationships between State 3 (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P) or Submaximal State 3 (0.25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DP)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State 4 are presented.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6A13C6-2DCD-DF4A-A164-7AF6BA6D285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2392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 . Mitochondrial subunits are not differentially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ed with age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(A)Mitochondrial complexes subunits were not differentially represented with age in our sample (p&gt;0.05)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Representative western blot images from the OXHOS antibody, and </a:t>
            </a:r>
            <a:r>
              <a:rPr lang="en-US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nceau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taining; A.U: Arbitrary units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AABA09-3495-6C42-B662-1AC3EBD9463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1882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3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28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960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1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49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301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753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087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3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508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7A0AC-7B3D-F649-8081-C2AF71D45771}" type="datetimeFigureOut">
              <a:rPr lang="en-US" smtClean="0"/>
              <a:t>11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41F4D-3A86-6E4A-A606-3E98E47E27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281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16820" y="231182"/>
            <a:ext cx="1091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Figure S1. Representative mitochondrial oxygen consumption spectra using </a:t>
            </a:r>
            <a:r>
              <a:rPr lang="en-US" b="1" dirty="0" err="1" smtClean="0"/>
              <a:t>Oroboros</a:t>
            </a:r>
            <a:r>
              <a:rPr lang="en-US" b="1" dirty="0" smtClean="0"/>
              <a:t> </a:t>
            </a:r>
            <a:r>
              <a:rPr lang="en-US" b="1" dirty="0" err="1" smtClean="0"/>
              <a:t>Oxygraph</a:t>
            </a:r>
            <a:r>
              <a:rPr lang="en-US" b="1" dirty="0" smtClean="0"/>
              <a:t> 2k </a:t>
            </a:r>
            <a:endParaRPr lang="en-US" b="1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815" y="838200"/>
            <a:ext cx="10718136" cy="601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2076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33858" y="0"/>
            <a:ext cx="110616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Figure S</a:t>
            </a:r>
            <a:r>
              <a:rPr lang="en-US" b="1" dirty="0"/>
              <a:t>2</a:t>
            </a:r>
            <a:r>
              <a:rPr lang="en-US" b="1" dirty="0" smtClean="0"/>
              <a:t>. Representative scatterplots showing the association of mitochondrial respiration with body composition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384645" y="682388"/>
            <a:ext cx="19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8550" y="457200"/>
            <a:ext cx="9994900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6868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728" y="172112"/>
            <a:ext cx="11504168" cy="66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7121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3225" r="280"/>
          <a:stretch/>
        </p:blipFill>
        <p:spPr>
          <a:xfrm>
            <a:off x="0" y="264708"/>
            <a:ext cx="11978640" cy="628519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2480" y="0"/>
            <a:ext cx="1091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Figure S4. Mitochondrial subunits are not differentially expressed with ag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45754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6</TotalTime>
  <Words>273</Words>
  <Application>Microsoft Macintosh PowerPoint</Application>
  <PresentationFormat>Widescreen</PresentationFormat>
  <Paragraphs>11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Calibri</vt:lpstr>
      <vt:lpstr>Calibri Light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zalez Freire, Marta (NIH/NIA/IRP) [F]</dc:creator>
  <cp:lastModifiedBy>Gonzalez Freire, Marta (NIH/NIA/IRP) [F]</cp:lastModifiedBy>
  <cp:revision>17</cp:revision>
  <dcterms:created xsi:type="dcterms:W3CDTF">2017-05-09T20:04:55Z</dcterms:created>
  <dcterms:modified xsi:type="dcterms:W3CDTF">2017-11-29T20:46:06Z</dcterms:modified>
</cp:coreProperties>
</file>